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460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270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4786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8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229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479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305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55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134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4232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710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92E12-D855-4917-8581-3E6AC5A2D2FC}" type="datetimeFigureOut">
              <a:rPr lang="en-GB" smtClean="0"/>
              <a:t>16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83075-BA9F-44F3-A387-C5214E6332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5535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fficeArt object" descr="Picture 1"/>
          <p:cNvPicPr/>
          <p:nvPr/>
        </p:nvPicPr>
        <p:blipFill>
          <a:blip r:embed="rId2"/>
          <a:stretch>
            <a:fillRect/>
          </a:stretch>
        </p:blipFill>
        <p:spPr>
          <a:xfrm>
            <a:off x="2602348" y="2131966"/>
            <a:ext cx="2876550" cy="215709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pic>
        <p:nvPicPr>
          <p:cNvPr id="5" name="officeArt object" descr="Picture 3"/>
          <p:cNvPicPr/>
          <p:nvPr/>
        </p:nvPicPr>
        <p:blipFill>
          <a:blip r:embed="rId3"/>
          <a:stretch>
            <a:fillRect/>
          </a:stretch>
        </p:blipFill>
        <p:spPr>
          <a:xfrm>
            <a:off x="5545680" y="2124272"/>
            <a:ext cx="2853853" cy="2164507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6" name="Rectangle 5"/>
          <p:cNvSpPr/>
          <p:nvPr/>
        </p:nvSpPr>
        <p:spPr>
          <a:xfrm>
            <a:off x="2582745" y="4503679"/>
            <a:ext cx="6096000" cy="258917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Figure </a:t>
            </a:r>
            <a:r>
              <a:rPr lang="en-US" sz="1000" b="1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S1</a:t>
            </a:r>
            <a:r>
              <a:rPr lang="en-US" sz="1000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. Discograms verifying </a:t>
            </a:r>
            <a:r>
              <a:rPr lang="en-US" sz="1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the accuracy of this percutaneous </a:t>
            </a:r>
            <a:r>
              <a:rPr lang="en-US" sz="10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intradiscal</a:t>
            </a:r>
            <a:r>
              <a:rPr lang="en-US" sz="1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 lumbar spine injection technique.</a:t>
            </a:r>
            <a:endParaRPr lang="en-GB" sz="10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+mj-lt"/>
              <a:ea typeface="Arial Unicode MS"/>
              <a:cs typeface="Arial Unicode MS"/>
            </a:endParaRPr>
          </a:p>
        </p:txBody>
      </p:sp>
    </p:spTree>
    <p:extLst>
      <p:ext uri="{BB962C8B-B14F-4D97-AF65-F5344CB8AC3E}">
        <p14:creationId xmlns:p14="http://schemas.microsoft.com/office/powerpoint/2010/main" val="4961665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fficeArt object" descr="image7.png"/>
          <p:cNvPicPr/>
          <p:nvPr/>
        </p:nvPicPr>
        <p:blipFill>
          <a:blip r:embed="rId2"/>
          <a:stretch>
            <a:fillRect/>
          </a:stretch>
        </p:blipFill>
        <p:spPr>
          <a:xfrm>
            <a:off x="4069493" y="1529858"/>
            <a:ext cx="2466975" cy="324802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5" name="Rectangle 4"/>
          <p:cNvSpPr/>
          <p:nvPr/>
        </p:nvSpPr>
        <p:spPr>
          <a:xfrm>
            <a:off x="3094133" y="4932639"/>
            <a:ext cx="4554354" cy="4462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it-IT" sz="1000" b="1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Figure </a:t>
            </a:r>
            <a:r>
              <a:rPr lang="it-IT" sz="1000" b="1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S2.  </a:t>
            </a:r>
            <a:r>
              <a:rPr lang="it-IT" sz="1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25 </a:t>
            </a:r>
            <a:r>
              <a:rPr lang="it-IT" sz="1000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gauge </a:t>
            </a:r>
            <a:r>
              <a:rPr lang="it-IT" sz="1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needles within the </a:t>
            </a:r>
            <a:r>
              <a:rPr lang="it-IT" sz="1000" dirty="0" smtClean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20 gauge </a:t>
            </a:r>
            <a:r>
              <a:rPr lang="it-IT" sz="10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+mj-lt"/>
                <a:ea typeface="Arial Unicode MS"/>
                <a:cs typeface="Arial Unicode MS"/>
              </a:rPr>
              <a:t>introducer needles, serially spaced, extending into the lumbar discs.</a:t>
            </a:r>
            <a:endParaRPr lang="en-GB" sz="10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+mj-lt"/>
              <a:ea typeface="Arial Unicode MS"/>
              <a:cs typeface="Arial Unicode MS"/>
            </a:endParaRPr>
          </a:p>
        </p:txBody>
      </p:sp>
    </p:spTree>
    <p:extLst>
      <p:ext uri="{BB962C8B-B14F-4D97-AF65-F5344CB8AC3E}">
        <p14:creationId xmlns:p14="http://schemas.microsoft.com/office/powerpoint/2010/main" val="302344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8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Unicode MS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Dowell, Andrew</dc:creator>
  <cp:lastModifiedBy>McDowell, Andrew</cp:lastModifiedBy>
  <cp:revision>2</cp:revision>
  <dcterms:created xsi:type="dcterms:W3CDTF">2020-12-21T11:31:53Z</dcterms:created>
  <dcterms:modified xsi:type="dcterms:W3CDTF">2021-01-16T12:51:51Z</dcterms:modified>
</cp:coreProperties>
</file>